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71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OLAUSSEN Ken" initials="OK" lastIdx="9" clrIdx="0">
    <p:extLst>
      <p:ext uri="{19B8F6BF-5375-455C-9EA6-DF929625EA0E}">
        <p15:presenceInfo xmlns:p15="http://schemas.microsoft.com/office/powerpoint/2012/main" userId="S::Ken.OLAUSSEN@gustaveroussy.fr::b52c742c-e89a-44fb-b980-43c65ab3f22f" providerId="AD"/>
      </p:ext>
    </p:extLst>
  </p:cmAuthor>
  <p:cmAuthor id="2" name="FRIBOULET Luc" initials="FL" lastIdx="14" clrIdx="1">
    <p:extLst>
      <p:ext uri="{19B8F6BF-5375-455C-9EA6-DF929625EA0E}">
        <p15:presenceInfo xmlns:p15="http://schemas.microsoft.com/office/powerpoint/2012/main" userId="S::Luc.FRIBOULET@gustaveroussy.fr::24e6c35a-934b-461c-8797-c45cd64d339c" providerId="AD"/>
      </p:ext>
    </p:extLst>
  </p:cmAuthor>
  <p:cmAuthor id="3" name="Francesco Facchinetti" initials="FF" lastIdx="7" clrIdx="2">
    <p:extLst>
      <p:ext uri="{19B8F6BF-5375-455C-9EA6-DF929625EA0E}">
        <p15:presenceInfo xmlns:p15="http://schemas.microsoft.com/office/powerpoint/2012/main" userId="f3dc93800fbbcdac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essuno stile, nessuna grigli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34843"/>
    <p:restoredTop sz="96076"/>
  </p:normalViewPr>
  <p:slideViewPr>
    <p:cSldViewPr snapToGrid="0">
      <p:cViewPr varScale="1">
        <p:scale>
          <a:sx n="81" d="100"/>
          <a:sy n="81" d="100"/>
        </p:scale>
        <p:origin x="2000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D17D927-84AB-D343-A8FA-D1DF57CB95F5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7D9D5EC-21A0-0C4D-9161-B263BFB5BFB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783713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494071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644771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896505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591863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334090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378945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979706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245421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618666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433844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325213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72BFB9-D6F1-814D-A7D0-5CB60C0DE85D}" type="datetimeFigureOut">
              <a:rPr lang="it-IT" smtClean="0"/>
              <a:t>11/06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283304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33F44290-899B-0F6E-778C-A3878E9E7F8B}"/>
              </a:ext>
            </a:extLst>
          </p:cNvPr>
          <p:cNvSpPr txBox="1"/>
          <p:nvPr/>
        </p:nvSpPr>
        <p:spPr>
          <a:xfrm>
            <a:off x="528240" y="2173600"/>
            <a:ext cx="623832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Table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 S3. </a:t>
            </a:r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Tumor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types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, FGFR2 drivers, and clinical </a:t>
            </a:r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outcomes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suffering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 from </a:t>
            </a:r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tumors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other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than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intrahepatic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cholangiocarcinoma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treated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 with </a:t>
            </a:r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selective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 FGFR </a:t>
            </a:r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inhibitors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 algn="just"/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BOR: Best 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objective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response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; CR: Complete 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response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; PR: 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Partial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response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; SD: 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Stable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disease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; PFS: 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Progression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-free survival.</a:t>
            </a:r>
          </a:p>
        </p:txBody>
      </p:sp>
      <p:graphicFrame>
        <p:nvGraphicFramePr>
          <p:cNvPr id="5" name="Tabella 4">
            <a:extLst>
              <a:ext uri="{FF2B5EF4-FFF2-40B4-BE49-F238E27FC236}">
                <a16:creationId xmlns:a16="http://schemas.microsoft.com/office/drawing/2014/main" id="{0C880317-4FC0-FD29-0B18-515AA153ED5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90873125"/>
              </p:ext>
            </p:extLst>
          </p:nvPr>
        </p:nvGraphicFramePr>
        <p:xfrm>
          <a:off x="679148" y="350427"/>
          <a:ext cx="5499703" cy="1697046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72785">
                  <a:extLst>
                    <a:ext uri="{9D8B030D-6E8A-4147-A177-3AD203B41FA5}">
                      <a16:colId xmlns:a16="http://schemas.microsoft.com/office/drawing/2014/main" val="300397261"/>
                    </a:ext>
                  </a:extLst>
                </a:gridCol>
                <a:gridCol w="1674951">
                  <a:extLst>
                    <a:ext uri="{9D8B030D-6E8A-4147-A177-3AD203B41FA5}">
                      <a16:colId xmlns:a16="http://schemas.microsoft.com/office/drawing/2014/main" val="3740184476"/>
                    </a:ext>
                  </a:extLst>
                </a:gridCol>
                <a:gridCol w="1053000">
                  <a:extLst>
                    <a:ext uri="{9D8B030D-6E8A-4147-A177-3AD203B41FA5}">
                      <a16:colId xmlns:a16="http://schemas.microsoft.com/office/drawing/2014/main" val="1316851048"/>
                    </a:ext>
                  </a:extLst>
                </a:gridCol>
                <a:gridCol w="672750">
                  <a:extLst>
                    <a:ext uri="{9D8B030D-6E8A-4147-A177-3AD203B41FA5}">
                      <a16:colId xmlns:a16="http://schemas.microsoft.com/office/drawing/2014/main" val="1305023328"/>
                    </a:ext>
                  </a:extLst>
                </a:gridCol>
                <a:gridCol w="819000">
                  <a:extLst>
                    <a:ext uri="{9D8B030D-6E8A-4147-A177-3AD203B41FA5}">
                      <a16:colId xmlns:a16="http://schemas.microsoft.com/office/drawing/2014/main" val="3588753611"/>
                    </a:ext>
                  </a:extLst>
                </a:gridCol>
                <a:gridCol w="807217">
                  <a:extLst>
                    <a:ext uri="{9D8B030D-6E8A-4147-A177-3AD203B41FA5}">
                      <a16:colId xmlns:a16="http://schemas.microsoft.com/office/drawing/2014/main" val="117926281"/>
                    </a:ext>
                  </a:extLst>
                </a:gridCol>
              </a:tblGrid>
              <a:tr h="162099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7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s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7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mor type</a:t>
                      </a:r>
                      <a:endParaRPr lang="it-IT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iver</a:t>
                      </a: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hibitor</a:t>
                      </a:r>
                      <a:endParaRPr lang="fr-FR" sz="7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OR</a:t>
                      </a: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FS (</a:t>
                      </a:r>
                      <a:r>
                        <a:rPr lang="fr-FR" sz="7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nths</a:t>
                      </a:r>
                      <a:r>
                        <a:rPr lang="fr-FR" sz="7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64393475"/>
                  </a:ext>
                </a:extLst>
              </a:tr>
              <a:tr h="162099">
                <a:tc>
                  <a:txBody>
                    <a:bodyPr/>
                    <a:lstStyle/>
                    <a:p>
                      <a:pPr algn="ctr"/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904</a:t>
                      </a: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rothelial</a:t>
                      </a:r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ancer</a:t>
                      </a: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R2::FAM83H-AS1</a:t>
                      </a: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migatinib</a:t>
                      </a:r>
                      <a:endParaRPr lang="fr-FR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 (-100%)</a:t>
                      </a: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.9</a:t>
                      </a: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92146331"/>
                  </a:ext>
                </a:extLst>
              </a:tr>
              <a:tr h="162099">
                <a:tc>
                  <a:txBody>
                    <a:bodyPr/>
                    <a:lstStyle/>
                    <a:p>
                      <a:pPr algn="ctr"/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238</a:t>
                      </a: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ple-</a:t>
                      </a:r>
                      <a:r>
                        <a:rPr lang="fr-FR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gative</a:t>
                      </a:r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FR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east</a:t>
                      </a:r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ancer</a:t>
                      </a: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R2 C383R</a:t>
                      </a: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4">
                  <a:txBody>
                    <a:bodyPr/>
                    <a:lstStyle/>
                    <a:p>
                      <a:pPr algn="ctr"/>
                      <a:r>
                        <a:rPr lang="fr-FR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dafitinib</a:t>
                      </a:r>
                      <a:endParaRPr lang="fr-FR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0655" marR="50655" marT="25328" marB="253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 (-59%)</a:t>
                      </a: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.3</a:t>
                      </a: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5672646"/>
                  </a:ext>
                </a:extLst>
              </a:tr>
              <a:tr h="162099">
                <a:tc>
                  <a:txBody>
                    <a:bodyPr/>
                    <a:lstStyle/>
                    <a:p>
                      <a:pPr algn="ctr"/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1035</a:t>
                      </a: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ncer of </a:t>
                      </a:r>
                      <a:r>
                        <a:rPr lang="fr-FR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known</a:t>
                      </a:r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FR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ary</a:t>
                      </a:r>
                      <a:endParaRPr lang="fr-FR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R2 S276P</a:t>
                      </a: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/>
                      <a:r>
                        <a:rPr lang="fr-FR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dafitinib</a:t>
                      </a:r>
                      <a:endParaRPr lang="fr-FR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345" marR="62345" marT="31173" marB="31173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 (-40%)</a:t>
                      </a: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0</a:t>
                      </a: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11770032"/>
                  </a:ext>
                </a:extLst>
              </a:tr>
              <a:tr h="162099">
                <a:tc>
                  <a:txBody>
                    <a:bodyPr/>
                    <a:lstStyle/>
                    <a:p>
                      <a:pPr algn="ctr"/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1056</a:t>
                      </a: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mg</a:t>
                      </a:r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FR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enocarcinoma</a:t>
                      </a:r>
                      <a:endParaRPr lang="fr-FR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R2::TACC2</a:t>
                      </a: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/>
                      <a:r>
                        <a:rPr lang="fr-FR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dafitinib</a:t>
                      </a:r>
                      <a:endParaRPr lang="fr-FR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345" marR="62345" marT="31173" marB="31173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 (-10%)</a:t>
                      </a: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2</a:t>
                      </a: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66541777"/>
                  </a:ext>
                </a:extLst>
              </a:tr>
              <a:tr h="162099">
                <a:tc>
                  <a:txBody>
                    <a:bodyPr/>
                    <a:lstStyle/>
                    <a:p>
                      <a:pPr algn="ctr"/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97</a:t>
                      </a: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-grade </a:t>
                      </a:r>
                      <a:r>
                        <a:rPr lang="fr-FR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ous</a:t>
                      </a:r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FR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varian</a:t>
                      </a:r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ancer </a:t>
                      </a: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R2::FAM16</a:t>
                      </a: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/>
                      <a:r>
                        <a:rPr lang="fr-FR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dafitinib</a:t>
                      </a:r>
                      <a:endParaRPr lang="fr-FR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345" marR="62345" marT="31173" marB="31173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 (-14%)</a:t>
                      </a: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6</a:t>
                      </a: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4551891"/>
                  </a:ext>
                </a:extLst>
              </a:tr>
              <a:tr h="0">
                <a:tc gridSpan="6">
                  <a:txBody>
                    <a:bodyPr/>
                    <a:lstStyle/>
                    <a:p>
                      <a:pPr algn="ctr"/>
                      <a:endParaRPr lang="fr-FR" sz="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fr-FR" sz="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345" marR="62345" marT="31173" marB="31173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fr-FR" sz="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345" marR="62345" marT="31173" marB="31173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fr-FR" sz="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345" marR="62345" marT="31173" marB="31173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fr-FR" sz="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345" marR="62345" marT="31173" marB="31173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40205730"/>
                  </a:ext>
                </a:extLst>
              </a:tr>
              <a:tr h="162099">
                <a:tc>
                  <a:txBody>
                    <a:bodyPr/>
                    <a:lstStyle/>
                    <a:p>
                      <a:pPr algn="ctr"/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1271</a:t>
                      </a: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uodenal cancer</a:t>
                      </a:r>
                      <a:endParaRPr lang="fr-FR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R2::NEK1</a:t>
                      </a: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4">
                  <a:txBody>
                    <a:bodyPr/>
                    <a:lstStyle/>
                    <a:p>
                      <a:pPr algn="ctr"/>
                      <a:r>
                        <a:rPr lang="fr-FR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tibatinib</a:t>
                      </a:r>
                      <a:endParaRPr lang="fr-FR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0655" marR="50655" marT="25328" marB="253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 (-24%)</a:t>
                      </a: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5</a:t>
                      </a: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28437262"/>
                  </a:ext>
                </a:extLst>
              </a:tr>
              <a:tr h="162099">
                <a:tc>
                  <a:txBody>
                    <a:bodyPr/>
                    <a:lstStyle/>
                    <a:p>
                      <a:pPr algn="ctr"/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1154</a:t>
                      </a: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ncreatic ductal adenocarcinoma</a:t>
                      </a:r>
                      <a:endParaRPr lang="fr-FR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R2::CCSER2</a:t>
                      </a: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/>
                      <a:r>
                        <a:rPr lang="fr-FR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tibatinib</a:t>
                      </a:r>
                      <a:endParaRPr lang="fr-FR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345" marR="62345" marT="31173" marB="3117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 (0%)</a:t>
                      </a: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3</a:t>
                      </a: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7893492"/>
                  </a:ext>
                </a:extLst>
              </a:tr>
              <a:tr h="162099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460</a:t>
                      </a: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7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renocortical</a:t>
                      </a:r>
                      <a:r>
                        <a:rPr lang="fr-FR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FR" sz="7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cinoma</a:t>
                      </a:r>
                      <a:endParaRPr lang="fr-FR" sz="7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R2::STRN4</a:t>
                      </a: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/>
                      <a:r>
                        <a:rPr lang="fr-FR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tibatinib</a:t>
                      </a:r>
                      <a:endParaRPr lang="fr-FR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345" marR="62345" marT="31173" marB="31173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 (0%)</a:t>
                      </a: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8</a:t>
                      </a: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10917403"/>
                  </a:ext>
                </a:extLst>
              </a:tr>
              <a:tr h="162099">
                <a:tc>
                  <a:txBody>
                    <a:bodyPr/>
                    <a:lstStyle/>
                    <a:p>
                      <a:pPr algn="ctr"/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C793</a:t>
                      </a: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-grade </a:t>
                      </a:r>
                      <a:r>
                        <a:rPr lang="fr-FR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ous</a:t>
                      </a:r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FR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varian</a:t>
                      </a:r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ancer</a:t>
                      </a: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R2::TACC2</a:t>
                      </a: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tibatinib</a:t>
                      </a:r>
                      <a:endParaRPr lang="fr-FR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345" marR="62345" marT="31173" marB="31173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 (+17%)</a:t>
                      </a: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6</a:t>
                      </a:r>
                    </a:p>
                  </a:txBody>
                  <a:tcPr marL="50655" marR="50655" marT="25328" marB="2532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3613368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7313110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62180</TotalTime>
  <Words>173</Words>
  <Application>Microsoft Macintosh PowerPoint</Application>
  <PresentationFormat>A4 (21x29,7 cm)</PresentationFormat>
  <Paragraphs>56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rancesco Facchinetti</dc:creator>
  <cp:lastModifiedBy>Francesco Facchinetti</cp:lastModifiedBy>
  <cp:revision>143</cp:revision>
  <dcterms:created xsi:type="dcterms:W3CDTF">2022-09-21T18:46:54Z</dcterms:created>
  <dcterms:modified xsi:type="dcterms:W3CDTF">2024-06-11T15:10:37Z</dcterms:modified>
</cp:coreProperties>
</file>